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81" d="100"/>
          <a:sy n="81" d="100"/>
        </p:scale>
        <p:origin x="-280" y="-240"/>
      </p:cViewPr>
      <p:guideLst>
        <p:guide orient="horz" pos="1856"/>
        <p:guide pos="543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2906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8602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7974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47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3843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2061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0709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5752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9070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9394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6303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079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4" Type="http://schemas.openxmlformats.org/officeDocument/2006/relationships/image" Target="../media/image6.jpg"/><Relationship Id="rId5" Type="http://schemas.openxmlformats.org/officeDocument/2006/relationships/image" Target="../media/image7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4" Type="http://schemas.openxmlformats.org/officeDocument/2006/relationships/image" Target="../media/image10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jp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12.jpg"/><Relationship Id="rId5" Type="http://schemas.openxmlformats.org/officeDocument/2006/relationships/image" Target="../media/image13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MMH3438 colon 2-1 Casp3 x400 scale bar 20um 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7443" y="2195186"/>
            <a:ext cx="3976335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" name="Bild 2" descr="MMH3443 colon 1-10 Casp3 x400 scale bar 20um 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6856" y="2200726"/>
            <a:ext cx="3967576" cy="298141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" name="Bild 1" descr="MMH3463 colon 1-1 Casp3 x400 scale bar 20um 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19" y="2195190"/>
            <a:ext cx="3971620" cy="298445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9" name="Textfeld 28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81250" y="328670"/>
            <a:ext cx="582211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 smtClean="0">
                <a:latin typeface="Arial"/>
                <a:cs typeface="Arial"/>
              </a:rPr>
              <a:t>A</a:t>
            </a:r>
            <a:endParaRPr lang="de-DE" sz="4400" b="1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825200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err="1" smtClean="0">
                <a:latin typeface="Arial"/>
                <a:cs typeface="Arial"/>
              </a:rPr>
              <a:t>Apoptotic</a:t>
            </a:r>
            <a:r>
              <a:rPr lang="de-DE" sz="4000" b="1" dirty="0" smtClean="0">
                <a:latin typeface="Arial"/>
                <a:cs typeface="Arial"/>
              </a:rPr>
              <a:t> Cells (COLON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400 </a:t>
            </a:r>
            <a:r>
              <a:rPr lang="de-DE" sz="2400" b="1" dirty="0" smtClean="0">
                <a:latin typeface="Arial"/>
                <a:cs typeface="Arial"/>
              </a:rPr>
              <a:t>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</a:t>
            </a:r>
            <a:r>
              <a:rPr lang="de-DE" sz="2400" b="1" dirty="0">
                <a:latin typeface="Arial"/>
                <a:cs typeface="Arial"/>
              </a:rPr>
              <a:t>2</a:t>
            </a:r>
            <a:r>
              <a:rPr lang="de-DE" sz="2400" b="1" dirty="0" smtClean="0">
                <a:latin typeface="Arial"/>
                <a:cs typeface="Arial"/>
              </a:rPr>
              <a:t>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776461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 4" descr="MMH3443 colon-1 4-1 Ki67 x100 scale bar 100um 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91" y="2163826"/>
            <a:ext cx="3966664" cy="298073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" name="Bild 3" descr="MMH3443 colon-1 1-5 Ki67 x100 scale bar 100um 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4223" y="2163826"/>
            <a:ext cx="3976339" cy="2988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" name="Bild 2" descr="MMH3438 colon 2-1 Ki67 x100 scale bar 100um 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6583" y="2163826"/>
            <a:ext cx="3976339" cy="2988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1" name="Textfeld 10"/>
          <p:cNvSpPr txBox="1"/>
          <p:nvPr/>
        </p:nvSpPr>
        <p:spPr>
          <a:xfrm>
            <a:off x="381250" y="328670"/>
            <a:ext cx="59215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2574336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err="1" smtClean="0">
                <a:latin typeface="Arial"/>
                <a:cs typeface="Arial"/>
              </a:rPr>
              <a:t>Proliferating</a:t>
            </a:r>
            <a:r>
              <a:rPr lang="de-DE" sz="4000" b="1" dirty="0" smtClean="0">
                <a:latin typeface="Arial"/>
                <a:cs typeface="Arial"/>
              </a:rPr>
              <a:t> Cells (COLON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100 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10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  <p:pic>
        <p:nvPicPr>
          <p:cNvPr id="2" name="Bild 1" descr="MMH3420 colon 1-3 Ki67 x100 scale bar 100um.jp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15279"/>
            <a:ext cx="95816" cy="72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4" name="Textfeld 13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166111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MMH3438 colon 2-5 CD3 x100 scale bar 100um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2186" y="2132468"/>
            <a:ext cx="3976335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" name="Bild 2" descr="MMH3443 colon-1 4-1 CD3 x100 scale bar 100um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16" y="2132466"/>
            <a:ext cx="3964606" cy="2979184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" name="Bild 1" descr="MMH3443 colon-1 1-4 CD3 x100 scale bar 100um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3449" y="2117905"/>
            <a:ext cx="3976338" cy="2987999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1" name="Textfeld 10"/>
          <p:cNvSpPr txBox="1"/>
          <p:nvPr/>
        </p:nvSpPr>
        <p:spPr>
          <a:xfrm>
            <a:off x="381250" y="328670"/>
            <a:ext cx="59215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>
                <a:latin typeface="Arial"/>
                <a:cs typeface="Arial"/>
              </a:rPr>
              <a:t>C</a:t>
            </a:r>
            <a:endParaRPr lang="de-DE" sz="4400" b="1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903595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smtClean="0">
                <a:latin typeface="Arial"/>
                <a:cs typeface="Arial"/>
              </a:rPr>
              <a:t>T </a:t>
            </a:r>
            <a:r>
              <a:rPr lang="de-DE" sz="4000" b="1" dirty="0" err="1" smtClean="0">
                <a:latin typeface="Arial"/>
                <a:cs typeface="Arial"/>
              </a:rPr>
              <a:t>Lymphocytes</a:t>
            </a:r>
            <a:r>
              <a:rPr lang="de-DE" sz="4000" b="1" dirty="0" smtClean="0">
                <a:latin typeface="Arial"/>
                <a:cs typeface="Arial"/>
              </a:rPr>
              <a:t> (COLON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100 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10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089078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MMH3438 colon 2-6 B220 x100 scale bar 100um.jpg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4700"/>
                    </a14:imgEffect>
                    <a14:imgEffect>
                      <a14:saturation sa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3232" y="2116787"/>
            <a:ext cx="3976336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" name="Bild 2" descr="MMH3443 colon-1 1-1 B220 x100 scale bar 100um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3448" y="2128059"/>
            <a:ext cx="3980635" cy="299122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" name="Bild 1" descr="MMH3443 colon-1 4-1 B220 x100 scale bar 100um.jp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92" y="2121460"/>
            <a:ext cx="3976336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1" name="Textfeld 10"/>
          <p:cNvSpPr txBox="1"/>
          <p:nvPr/>
        </p:nvSpPr>
        <p:spPr>
          <a:xfrm>
            <a:off x="381250" y="328670"/>
            <a:ext cx="59215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>
                <a:latin typeface="Arial"/>
                <a:cs typeface="Arial"/>
              </a:rPr>
              <a:t>D</a:t>
            </a:r>
            <a:endParaRPr lang="de-DE" sz="4400" b="1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778163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smtClean="0">
                <a:latin typeface="Arial"/>
                <a:cs typeface="Arial"/>
              </a:rPr>
              <a:t>B </a:t>
            </a:r>
            <a:r>
              <a:rPr lang="de-DE" sz="4000" b="1" dirty="0" err="1" smtClean="0">
                <a:latin typeface="Arial"/>
                <a:cs typeface="Arial"/>
              </a:rPr>
              <a:t>Lymphocytes</a:t>
            </a:r>
            <a:r>
              <a:rPr lang="de-DE" sz="4000" b="1" dirty="0" smtClean="0">
                <a:latin typeface="Arial"/>
                <a:cs typeface="Arial"/>
              </a:rPr>
              <a:t> (</a:t>
            </a:r>
            <a:r>
              <a:rPr lang="de-DE" sz="4000" b="1" dirty="0" smtClean="0">
                <a:latin typeface="Arial"/>
                <a:cs typeface="Arial"/>
              </a:rPr>
              <a:t>COLON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100 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10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958695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Macintosh PowerPoint</Application>
  <PresentationFormat>Benutzerdefiniert</PresentationFormat>
  <Paragraphs>24</Paragraphs>
  <Slides>4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5" baseType="lpstr"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>Charite Universitaetsmedizin Berli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ühl, Anja</dc:creator>
  <cp:lastModifiedBy>Markus Heimesaat</cp:lastModifiedBy>
  <cp:revision>37</cp:revision>
  <cp:lastPrinted>2017-08-16T14:08:43Z</cp:lastPrinted>
  <dcterms:created xsi:type="dcterms:W3CDTF">2017-08-15T15:55:34Z</dcterms:created>
  <dcterms:modified xsi:type="dcterms:W3CDTF">2018-11-16T17:51:31Z</dcterms:modified>
</cp:coreProperties>
</file>